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28374-A597-4877-8B36-15F346BDCF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2FF72C-0B1E-4091-9583-3B25133920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C2590-1B2D-41EC-9D8D-D9230BF9AA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6A02BA-0FEB-40C6-A1CA-214F12D5F7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622AA-7026-465E-8333-60DA3FF398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4F4DA-1A4E-4FA6-BA69-BED2543771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E79459-5385-4DCD-B81C-1755E3B835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DA198-1301-4685-8036-D140363736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1FC02-C59D-4EE1-9CCF-06478601FF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312CB-CD6E-4C2D-B83B-32C2F5DCE3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24A500-438A-491E-85AB-93947B6C01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26962-0F58-4B10-87E2-6DB2FD7096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FC48E6-4F34-4B78-9BEB-C3762EAC3FE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6"/>
          <p:cNvSpPr/>
          <p:nvPr/>
        </p:nvSpPr>
        <p:spPr>
          <a:xfrm>
            <a:off x="183240" y="11736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7"/>
          <p:cNvSpPr/>
          <p:nvPr/>
        </p:nvSpPr>
        <p:spPr>
          <a:xfrm>
            <a:off x="429120" y="77472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10"/>
          <p:cNvSpPr/>
          <p:nvPr/>
        </p:nvSpPr>
        <p:spPr>
          <a:xfrm>
            <a:off x="4584240" y="77472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1"/>
          <p:cNvSpPr/>
          <p:nvPr/>
        </p:nvSpPr>
        <p:spPr>
          <a:xfrm>
            <a:off x="428760" y="3425760"/>
            <a:ext cx="308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2"/>
          <p:cNvSpPr/>
          <p:nvPr/>
        </p:nvSpPr>
        <p:spPr>
          <a:xfrm>
            <a:off x="4591800" y="341784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oup 5"/>
          <p:cNvGrpSpPr/>
          <p:nvPr/>
        </p:nvGrpSpPr>
        <p:grpSpPr>
          <a:xfrm>
            <a:off x="754200" y="3510000"/>
            <a:ext cx="7835760" cy="2320920"/>
            <a:chOff x="754200" y="3510000"/>
            <a:chExt cx="7835760" cy="2320920"/>
          </a:xfrm>
        </p:grpSpPr>
        <p:pic>
          <p:nvPicPr>
            <p:cNvPr id="47" name="Picture 3" descr=""/>
            <p:cNvPicPr/>
            <p:nvPr/>
          </p:nvPicPr>
          <p:blipFill>
            <a:blip r:embed="rId1"/>
            <a:stretch/>
          </p:blipFill>
          <p:spPr>
            <a:xfrm>
              <a:off x="754200" y="4014360"/>
              <a:ext cx="3816000" cy="1816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4" descr=""/>
            <p:cNvPicPr/>
            <p:nvPr/>
          </p:nvPicPr>
          <p:blipFill>
            <a:blip r:embed="rId2"/>
            <a:stretch/>
          </p:blipFill>
          <p:spPr>
            <a:xfrm>
              <a:off x="4798440" y="4014360"/>
              <a:ext cx="3791520" cy="1774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8"/>
            <p:cNvSpPr/>
            <p:nvPr/>
          </p:nvSpPr>
          <p:spPr>
            <a:xfrm>
              <a:off x="1443240" y="3510000"/>
              <a:ext cx="64414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Q/- CTX+Gan, mouse #1                                  p53Q/- CTX+Gan, mouse #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(lung, pneumonia)                                                    (lung, atelectasis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0" name="TextBox 14"/>
          <p:cNvSpPr/>
          <p:nvPr/>
        </p:nvSpPr>
        <p:spPr>
          <a:xfrm>
            <a:off x="844920" y="1512720"/>
            <a:ext cx="655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  <a:ea typeface="Arial"/>
              </a:rPr>
              <a:t>H&amp;E                              H&amp;E                                    H&amp;E                               H&amp;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1" name="Group 13"/>
          <p:cNvGrpSpPr/>
          <p:nvPr/>
        </p:nvGrpSpPr>
        <p:grpSpPr>
          <a:xfrm>
            <a:off x="743040" y="849240"/>
            <a:ext cx="7829640" cy="2403720"/>
            <a:chOff x="743040" y="849240"/>
            <a:chExt cx="7829640" cy="2403720"/>
          </a:xfrm>
        </p:grpSpPr>
        <p:pic>
          <p:nvPicPr>
            <p:cNvPr id="52" name="Picture 1" descr=""/>
            <p:cNvPicPr/>
            <p:nvPr/>
          </p:nvPicPr>
          <p:blipFill>
            <a:blip r:embed="rId3"/>
            <a:stretch/>
          </p:blipFill>
          <p:spPr>
            <a:xfrm>
              <a:off x="4744800" y="1240560"/>
              <a:ext cx="3827880" cy="2012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9" descr=""/>
            <p:cNvPicPr/>
            <p:nvPr/>
          </p:nvPicPr>
          <p:blipFill>
            <a:blip r:embed="rId4"/>
            <a:stretch/>
          </p:blipFill>
          <p:spPr>
            <a:xfrm>
              <a:off x="743040" y="1279080"/>
              <a:ext cx="3858480" cy="1884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Box 2"/>
            <p:cNvSpPr/>
            <p:nvPr/>
          </p:nvSpPr>
          <p:spPr>
            <a:xfrm>
              <a:off x="1469880" y="849240"/>
              <a:ext cx="64414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Q/- CTX+Gan, mouse #6                                  p53Q/- CTX+Gan, mouse #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(fibrosarcoma, anus)                                               (relapsed T-lymphoma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5"/>
            <p:cNvSpPr/>
            <p:nvPr/>
          </p:nvSpPr>
          <p:spPr>
            <a:xfrm>
              <a:off x="844920" y="1414800"/>
              <a:ext cx="6721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Arial"/>
                  <a:ea typeface="Arial"/>
                </a:rPr>
                <a:t>H&amp;E                              mutp53                              H&amp;E                              mutp5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05T17:53:33Z</dcterms:created>
  <dc:creator>Molllab</dc:creator>
  <dc:description/>
  <dc:language>en-US</dc:language>
  <cp:lastModifiedBy>KC.Lalitha</cp:lastModifiedBy>
  <dcterms:modified xsi:type="dcterms:W3CDTF">2017-03-15T11:37:36Z</dcterms:modified>
  <cp:revision>14</cp:revision>
  <dc:subject/>
  <dc:title>PowerPoint Presentation</dc:title>
</cp:coreProperties>
</file>